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46" autoAdjust="0"/>
    <p:restoredTop sz="94660"/>
  </p:normalViewPr>
  <p:slideViewPr>
    <p:cSldViewPr>
      <p:cViewPr varScale="1">
        <p:scale>
          <a:sx n="113" d="100"/>
          <a:sy n="113" d="100"/>
        </p:scale>
        <p:origin x="-121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922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160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228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250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320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90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974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700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83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842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79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E0C49-E32B-4AE8-BC54-161ED0355DC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EE840-10C7-4AA4-B165-D77B87FDF3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067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65797" y="3012048"/>
            <a:ext cx="2710781" cy="307777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square" rtlCol="0">
            <a:spAutoFit/>
          </a:bodyPr>
          <a:lstStyle/>
          <a:p>
            <a:r>
              <a:rPr lang="sv-SE" sz="14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on-small cell lung cancer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65797" y="1211848"/>
            <a:ext cx="2710783" cy="307777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ast canc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ER+ tam-treated</a:t>
            </a:r>
            <a:endParaRPr lang="sv-SE" sz="1400" dirty="0" smtClean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765799" y="707792"/>
            <a:ext cx="5478714" cy="307777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sv-SE" sz="1400" smtClean="0">
                <a:latin typeface="Arial" panose="020B0604020202020204" pitchFamily="34" charset="0"/>
                <a:cs typeface="Arial" panose="020B0604020202020204" pitchFamily="34" charset="0"/>
              </a:rPr>
              <a:t>Validation </a:t>
            </a:r>
            <a:r>
              <a:rPr lang="sv-S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late-type genes</a:t>
            </a:r>
            <a:endParaRPr lang="sv-SE" sz="1400" dirty="0" smtClean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765797" y="1499880"/>
            <a:ext cx="1418079" cy="1446550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2093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7705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26971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2990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494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6532</a:t>
            </a:r>
            <a:r>
              <a:rPr lang="sv-SE" sz="1100" baseline="30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</a:t>
            </a:r>
            <a:endParaRPr lang="sv-SE" sz="1100" dirty="0" smtClean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6532</a:t>
            </a:r>
            <a:r>
              <a:rPr lang="sv-SE" sz="1100" baseline="30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</a:t>
            </a:r>
            <a:endParaRPr lang="sv-SE" sz="1100" dirty="0" smtClean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919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65797" y="3300080"/>
            <a:ext cx="1029073" cy="1785104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4814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9188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29013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0219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1210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141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7745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4573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50081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hedde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37702" y="1499880"/>
            <a:ext cx="1728192" cy="1446550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 127 (11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81 (42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204 (29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26 (3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46 (9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59 (7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78 (20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72 (6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37702" y="3300080"/>
            <a:ext cx="1681707" cy="1785104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59 (9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37 (12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20 (4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56 (66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85 (15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44 (9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12 (61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61 (20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24 (33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272 (95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741539" y="1211848"/>
            <a:ext cx="2710781" cy="307777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square" rtlCol="0">
            <a:spAutoFit/>
          </a:bodyPr>
          <a:lstStyle/>
          <a:p>
            <a:r>
              <a:rPr lang="sv-SE" sz="14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Ovarian cancer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741539" y="1499880"/>
            <a:ext cx="1054597" cy="1446550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4764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8520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9829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26193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26712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0161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9891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Duke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732345" y="1499880"/>
            <a:ext cx="1656184" cy="1446550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35 (8 events)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5 (8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4 (8 events)</a:t>
            </a: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4 (24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 95 (55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7 (13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89 (32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6 (19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741539" y="3012048"/>
            <a:ext cx="2710781" cy="307777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square" rtlCol="0">
            <a:spAutoFit/>
          </a:bodyPr>
          <a:lstStyle/>
          <a:p>
            <a:r>
              <a:rPr lang="sv-SE" sz="14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Colon cancer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741539" y="3300080"/>
            <a:ext cx="1054597" cy="769441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4333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17537</a:t>
            </a: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39582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SE41258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732344" y="3300080"/>
            <a:ext cx="1719975" cy="769441"/>
          </a:xfrm>
          <a:prstGeom prst="rect">
            <a:avLst/>
          </a:prstGeom>
          <a:solidFill>
            <a:schemeClr val="bg1"/>
          </a:solidFill>
          <a:ln w="9525">
            <a:noFill/>
            <a:prstDash val="solid"/>
          </a:ln>
        </p:spPr>
        <p:txBody>
          <a:bodyPr wrap="square" rtlCol="0">
            <a:spAutoFit/>
          </a:bodyPr>
          <a:lstStyle/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125 (116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= 30 (2 events)</a:t>
            </a: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02 (21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</a:t>
            </a:r>
            <a:r>
              <a:rPr lang="sv-SE" sz="11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ATE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=</a:t>
            </a:r>
            <a:r>
              <a:rPr lang="sv-SE" sz="11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sv-SE" sz="11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1 (11 events)</a:t>
            </a:r>
            <a:endParaRPr lang="sv-SE" sz="11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60"/>
          <p:cNvSpPr/>
          <p:nvPr/>
        </p:nvSpPr>
        <p:spPr>
          <a:xfrm>
            <a:off x="235172" y="6237892"/>
            <a:ext cx="54477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aseline="30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 </a:t>
            </a:r>
            <a:r>
              <a:rPr lang="en-US" sz="800" dirty="0" err="1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ffymetrix</a:t>
            </a:r>
            <a:r>
              <a:rPr lang="en-US" sz="8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HG U133A array</a:t>
            </a:r>
            <a:endParaRPr lang="en-US" sz="8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62"/>
          <p:cNvSpPr/>
          <p:nvPr/>
        </p:nvSpPr>
        <p:spPr>
          <a:xfrm>
            <a:off x="229174" y="6453916"/>
            <a:ext cx="54477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aseline="300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 </a:t>
            </a:r>
            <a:r>
              <a:rPr lang="en-US" sz="8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ffymetrix</a:t>
            </a:r>
            <a:r>
              <a:rPr lang="en-US" sz="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HG </a:t>
            </a:r>
            <a:r>
              <a:rPr lang="en-US" sz="8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U133Plus 2.0 </a:t>
            </a:r>
            <a:r>
              <a:rPr lang="en-US" sz="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rray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1037715" y="33846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1 </a:t>
            </a:r>
            <a:r>
              <a:rPr lang="de-DE" dirty="0" err="1" smtClean="0"/>
              <a:t>Fig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81347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1</Words>
  <Application>Microsoft Office PowerPoint</Application>
  <PresentationFormat>Bildschirmpräsentation (4:3)</PresentationFormat>
  <Paragraphs>6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Birte Hellwig</cp:lastModifiedBy>
  <cp:revision>51</cp:revision>
  <cp:lastPrinted>2016-06-28T08:51:48Z</cp:lastPrinted>
  <dcterms:created xsi:type="dcterms:W3CDTF">2014-04-17T15:01:09Z</dcterms:created>
  <dcterms:modified xsi:type="dcterms:W3CDTF">2016-06-28T11:21:06Z</dcterms:modified>
</cp:coreProperties>
</file>